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588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952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788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281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355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900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058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64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769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136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214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277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374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7519326"/>
              </p:ext>
            </p:extLst>
          </p:nvPr>
        </p:nvGraphicFramePr>
        <p:xfrm>
          <a:off x="1144257" y="990600"/>
          <a:ext cx="6946387" cy="4713312"/>
        </p:xfrm>
        <a:graphic>
          <a:graphicData uri="http://schemas.openxmlformats.org/drawingml/2006/table">
            <a:tbl>
              <a:tblPr/>
              <a:tblGrid>
                <a:gridCol w="185432"/>
                <a:gridCol w="185432"/>
                <a:gridCol w="117115"/>
                <a:gridCol w="117115"/>
                <a:gridCol w="109795"/>
                <a:gridCol w="117115"/>
                <a:gridCol w="117115"/>
                <a:gridCol w="139074"/>
                <a:gridCol w="117115"/>
                <a:gridCol w="126875"/>
                <a:gridCol w="185432"/>
                <a:gridCol w="126875"/>
                <a:gridCol w="139074"/>
                <a:gridCol w="117115"/>
                <a:gridCol w="117115"/>
                <a:gridCol w="126875"/>
                <a:gridCol w="146394"/>
                <a:gridCol w="139074"/>
                <a:gridCol w="117115"/>
                <a:gridCol w="126875"/>
                <a:gridCol w="185432"/>
                <a:gridCol w="146394"/>
                <a:gridCol w="139074"/>
                <a:gridCol w="117115"/>
                <a:gridCol w="126875"/>
                <a:gridCol w="126875"/>
                <a:gridCol w="126875"/>
                <a:gridCol w="117115"/>
                <a:gridCol w="185432"/>
                <a:gridCol w="185432"/>
                <a:gridCol w="185432"/>
                <a:gridCol w="117115"/>
                <a:gridCol w="185432"/>
                <a:gridCol w="185432"/>
                <a:gridCol w="139074"/>
                <a:gridCol w="146394"/>
                <a:gridCol w="139074"/>
                <a:gridCol w="139074"/>
                <a:gridCol w="126875"/>
                <a:gridCol w="126875"/>
                <a:gridCol w="185432"/>
                <a:gridCol w="117115"/>
                <a:gridCol w="117115"/>
                <a:gridCol w="139074"/>
                <a:gridCol w="139074"/>
                <a:gridCol w="126875"/>
                <a:gridCol w="126875"/>
                <a:gridCol w="139074"/>
                <a:gridCol w="117115"/>
                <a:gridCol w="117115"/>
              </a:tblGrid>
              <a:tr h="808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2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1F1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8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2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8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2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sng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5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8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2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1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1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3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1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1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1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1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C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6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6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3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3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F8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F8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F8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F8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F8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F8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19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59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8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8C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8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2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D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D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D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F9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1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3A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A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A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A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A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E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90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60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60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60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60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40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20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20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40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60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80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5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7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A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A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3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6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6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8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2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F4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35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45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D5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F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D7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F7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F7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D7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A5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D4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D4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D4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A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D4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84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64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14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D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F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8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8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8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8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8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43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43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43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43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43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F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D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47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1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B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1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D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8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2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68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1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A7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67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47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D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C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5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5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08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1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2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86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3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1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3A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1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1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1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3A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0210"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347" marR="7347" marT="734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Left Bracket 4"/>
          <p:cNvSpPr/>
          <p:nvPr/>
        </p:nvSpPr>
        <p:spPr>
          <a:xfrm>
            <a:off x="1013520" y="3051816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538113" y="3126746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g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191233" y="3266565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sp-N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5585367" y="5738368"/>
            <a:ext cx="1308100" cy="109728"/>
          </a:xfrm>
          <a:prstGeom prst="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FF0000"/>
              </a:gs>
              <a:gs pos="100000">
                <a:srgbClr val="FF0000"/>
              </a:gs>
              <a:gs pos="100000">
                <a:srgbClr val="FF0000">
                  <a:lumMod val="100000"/>
                </a:srgb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5444969" y="5893755"/>
            <a:ext cx="15888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0                   50                100</a:t>
            </a:r>
            <a:endParaRPr lang="en-US" sz="1000" b="1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6831825" y="5699822"/>
            <a:ext cx="0" cy="186821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6209982" y="5706930"/>
            <a:ext cx="0" cy="186824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5551157" y="5706930"/>
            <a:ext cx="0" cy="186825"/>
          </a:xfrm>
          <a:prstGeom prst="line">
            <a:avLst/>
          </a:prstGeom>
          <a:ln w="12700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Left Bracket 12"/>
          <p:cNvSpPr/>
          <p:nvPr/>
        </p:nvSpPr>
        <p:spPr>
          <a:xfrm>
            <a:off x="1013520" y="3646176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eft Bracket 13"/>
          <p:cNvSpPr/>
          <p:nvPr/>
        </p:nvSpPr>
        <p:spPr>
          <a:xfrm>
            <a:off x="1013520" y="4240536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Bracket 14"/>
          <p:cNvSpPr/>
          <p:nvPr/>
        </p:nvSpPr>
        <p:spPr>
          <a:xfrm>
            <a:off x="1013520" y="4834896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Left Bracket 15"/>
          <p:cNvSpPr/>
          <p:nvPr/>
        </p:nvSpPr>
        <p:spPr>
          <a:xfrm>
            <a:off x="1013520" y="1264920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Left Bracket 16"/>
          <p:cNvSpPr/>
          <p:nvPr/>
        </p:nvSpPr>
        <p:spPr>
          <a:xfrm>
            <a:off x="1013520" y="1859280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Bracket 17"/>
          <p:cNvSpPr/>
          <p:nvPr/>
        </p:nvSpPr>
        <p:spPr>
          <a:xfrm>
            <a:off x="1013520" y="2453640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Left Bracket 18"/>
          <p:cNvSpPr/>
          <p:nvPr/>
        </p:nvSpPr>
        <p:spPr>
          <a:xfrm rot="10800000">
            <a:off x="8128258" y="3194304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Bracket 19"/>
          <p:cNvSpPr/>
          <p:nvPr/>
        </p:nvSpPr>
        <p:spPr>
          <a:xfrm rot="10800000">
            <a:off x="8128258" y="3788664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Bracket 20"/>
          <p:cNvSpPr/>
          <p:nvPr/>
        </p:nvSpPr>
        <p:spPr>
          <a:xfrm rot="10800000">
            <a:off x="8128258" y="4383024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Left Bracket 21"/>
          <p:cNvSpPr/>
          <p:nvPr/>
        </p:nvSpPr>
        <p:spPr>
          <a:xfrm rot="10800000">
            <a:off x="8128258" y="4977384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 Bracket 22"/>
          <p:cNvSpPr/>
          <p:nvPr/>
        </p:nvSpPr>
        <p:spPr>
          <a:xfrm rot="10800000">
            <a:off x="8128258" y="1411224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Left Bracket 23"/>
          <p:cNvSpPr/>
          <p:nvPr/>
        </p:nvSpPr>
        <p:spPr>
          <a:xfrm rot="10800000">
            <a:off x="8128258" y="2005584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Left Bracket 24"/>
          <p:cNvSpPr/>
          <p:nvPr/>
        </p:nvSpPr>
        <p:spPr>
          <a:xfrm rot="10800000">
            <a:off x="8128258" y="2599944"/>
            <a:ext cx="73152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658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74</TotalTime>
  <Words>417</Words>
  <Application>Microsoft Office PowerPoint</Application>
  <PresentationFormat>On-screen Show (4:3)</PresentationFormat>
  <Paragraphs>4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PNN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uantification of Mutant SPOP Proteins in Prostate Cancer Using Mass Spectrometry-Based Targeted Proteomics</dc:title>
  <dc:creator>test</dc:creator>
  <cp:lastModifiedBy>Liu, Tao</cp:lastModifiedBy>
  <cp:revision>19</cp:revision>
  <dcterms:created xsi:type="dcterms:W3CDTF">2017-05-12T18:52:21Z</dcterms:created>
  <dcterms:modified xsi:type="dcterms:W3CDTF">2017-07-15T07:27:36Z</dcterms:modified>
</cp:coreProperties>
</file>